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A5BB4-79F2-44B9-8439-E3F135915F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456B5-F8F3-41D4-985A-4582A94CE7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FB97C-D6E5-460C-ACE9-D58AE66537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B260F-E9AE-4AF6-AD22-28C99A25B9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0C558-E344-42C0-8B31-2552B79F6C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F6670-3CF3-4B45-9AF1-53554B6E31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AF23A-D41F-4801-8996-5EEE67A373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935BF-7DF9-4F42-9BC3-915383788E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DEC0F-C95F-494A-90AB-7B94FB1E1C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F47BC-E5A1-4BE1-865E-86E09EE0AF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F27E8-72E6-4571-B478-BE8E03EB7F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CD2DA-31E7-4E8D-A3DA-25FDF5BB75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D61AD1-62B2-4C7D-A698-BBA6DF808D16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4280" y="52560"/>
            <a:ext cx="219420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39680" y="1035000"/>
            <a:ext cx="6590880" cy="6778800"/>
            <a:chOff x="139680" y="1035000"/>
            <a:chExt cx="6590880" cy="6778800"/>
          </a:xfrm>
        </p:grpSpPr>
        <p:pic>
          <p:nvPicPr>
            <p:cNvPr id="43" name="" descr=""/>
            <p:cNvPicPr/>
            <p:nvPr/>
          </p:nvPicPr>
          <p:blipFill>
            <a:blip r:embed="rId1"/>
            <a:srcRect l="8458" t="66008" r="0" b="12002"/>
            <a:stretch/>
          </p:blipFill>
          <p:spPr>
            <a:xfrm>
              <a:off x="560520" y="4041720"/>
              <a:ext cx="5816520" cy="797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 flipH="1">
              <a:off x="5062680" y="4511520"/>
              <a:ext cx="690480" cy="71460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267800" y="5159520"/>
              <a:ext cx="10465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v. M8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937120" y="4394160"/>
              <a:ext cx="165240" cy="84924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535720" y="5138640"/>
              <a:ext cx="1098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2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pennellii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54160" y="3386160"/>
              <a:ext cx="550800" cy="6444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54160" y="3890880"/>
              <a:ext cx="244440" cy="644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5400000">
              <a:off x="1429560" y="3661560"/>
              <a:ext cx="644400" cy="915840"/>
            </a:xfrm>
            <a:custGeom>
              <a:avLst/>
              <a:gdLst>
                <a:gd name="textAreaLeft" fmla="*/ 189360 w 644400"/>
                <a:gd name="textAreaRight" fmla="*/ 644760 w 644400"/>
                <a:gd name="textAreaTop" fmla="*/ 38160 h 915840"/>
                <a:gd name="textAreaBottom" fmla="*/ 877680 h 9158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5400000">
              <a:off x="2437560" y="3569400"/>
              <a:ext cx="644400" cy="1100160"/>
            </a:xfrm>
            <a:custGeom>
              <a:avLst/>
              <a:gdLst>
                <a:gd name="textAreaLeft" fmla="*/ 189360 w 644400"/>
                <a:gd name="textAreaRight" fmla="*/ 644760 w 644400"/>
                <a:gd name="textAreaTop" fmla="*/ 45720 h 1100160"/>
                <a:gd name="textAreaBottom" fmla="*/ 1054440 h 1100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5400000">
              <a:off x="3383640" y="3723120"/>
              <a:ext cx="585720" cy="733680"/>
            </a:xfrm>
            <a:custGeom>
              <a:avLst/>
              <a:gdLst>
                <a:gd name="textAreaLeft" fmla="*/ 172080 w 585720"/>
                <a:gd name="textAreaRight" fmla="*/ 586080 w 585720"/>
                <a:gd name="textAreaTop" fmla="*/ 30240 h 733680"/>
                <a:gd name="textAreaBottom" fmla="*/ 703440 h 733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5400000">
              <a:off x="4086000" y="3754440"/>
              <a:ext cx="585720" cy="671400"/>
            </a:xfrm>
            <a:custGeom>
              <a:avLst/>
              <a:gdLst>
                <a:gd name="textAreaLeft" fmla="*/ 172080 w 585720"/>
                <a:gd name="textAreaRight" fmla="*/ 586080 w 585720"/>
                <a:gd name="textAreaTop" fmla="*/ 27720 h 671400"/>
                <a:gd name="textAreaBottom" fmla="*/ 643680 h 671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5400000">
              <a:off x="4998960" y="3513240"/>
              <a:ext cx="409680" cy="977760"/>
            </a:xfrm>
            <a:custGeom>
              <a:avLst/>
              <a:gdLst>
                <a:gd name="textAreaLeft" fmla="*/ 120240 w 409680"/>
                <a:gd name="textAreaRight" fmla="*/ 410040 w 409680"/>
                <a:gd name="textAreaTop" fmla="*/ 40680 h 977760"/>
                <a:gd name="textAreaBottom" fmla="*/ 937080 h 9777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41080" y="350532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ro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358640" y="350532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ro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371680" y="350532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ro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238560" y="3505320"/>
              <a:ext cx="866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ro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989520" y="3505320"/>
              <a:ext cx="866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ro1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751280" y="3505320"/>
              <a:ext cx="866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ro1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5400000">
              <a:off x="633600" y="3723480"/>
              <a:ext cx="585720" cy="733320"/>
            </a:xfrm>
            <a:custGeom>
              <a:avLst/>
              <a:gdLst>
                <a:gd name="textAreaLeft" fmla="*/ 172080 w 585720"/>
                <a:gd name="textAreaRight" fmla="*/ 586080 w 585720"/>
                <a:gd name="textAreaTop" fmla="*/ 30240 h 733320"/>
                <a:gd name="textAreaBottom" fmla="*/ 703080 h 733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" name=""/>
            <p:cNvGrpSpPr/>
            <p:nvPr/>
          </p:nvGrpSpPr>
          <p:grpSpPr>
            <a:xfrm>
              <a:off x="533520" y="1035000"/>
              <a:ext cx="6197040" cy="2404440"/>
              <a:chOff x="533520" y="1035000"/>
              <a:chExt cx="6197040" cy="2404440"/>
            </a:xfrm>
          </p:grpSpPr>
          <p:sp>
            <p:nvSpPr>
              <p:cNvPr id="63" name=""/>
              <p:cNvSpPr/>
              <p:nvPr/>
            </p:nvSpPr>
            <p:spPr>
              <a:xfrm>
                <a:off x="1739880" y="1035000"/>
                <a:ext cx="36187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mosomal location of </a:t>
                </a:r>
                <a:r>
                  <a:rPr b="1" i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MYB1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4" name="" descr=""/>
              <p:cNvPicPr/>
              <p:nvPr/>
            </p:nvPicPr>
            <p:blipFill>
              <a:blip r:embed="rId2"/>
              <a:srcRect l="5763" t="20003" r="0" b="60002"/>
              <a:stretch/>
            </p:blipFill>
            <p:spPr>
              <a:xfrm>
                <a:off x="533520" y="2051280"/>
                <a:ext cx="6162480" cy="796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"/>
              <p:cNvSpPr/>
              <p:nvPr/>
            </p:nvSpPr>
            <p:spPr>
              <a:xfrm rot="5400000">
                <a:off x="1026720" y="1474920"/>
                <a:ext cx="409680" cy="977760"/>
              </a:xfrm>
              <a:custGeom>
                <a:avLst/>
                <a:gdLst>
                  <a:gd name="textAreaLeft" fmla="*/ 120240 w 409680"/>
                  <a:gd name="textAreaRight" fmla="*/ 410040 w 409680"/>
                  <a:gd name="textAreaTop" fmla="*/ 40680 h 977760"/>
                  <a:gd name="textAreaBottom" fmla="*/ 937080 h 977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rot="5400000">
                <a:off x="1947960" y="1531440"/>
                <a:ext cx="644760" cy="1099800"/>
              </a:xfrm>
              <a:custGeom>
                <a:avLst/>
                <a:gdLst>
                  <a:gd name="textAreaLeft" fmla="*/ 189360 w 644760"/>
                  <a:gd name="textAreaRight" fmla="*/ 645120 w 644760"/>
                  <a:gd name="textAreaTop" fmla="*/ 45720 h 1099800"/>
                  <a:gd name="textAreaBottom" fmla="*/ 1054080 h 10998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rot="5400000">
                <a:off x="2833920" y="1745640"/>
                <a:ext cx="644760" cy="671040"/>
              </a:xfrm>
              <a:custGeom>
                <a:avLst/>
                <a:gdLst>
                  <a:gd name="textAreaLeft" fmla="*/ 189360 w 644760"/>
                  <a:gd name="textAreaRight" fmla="*/ 645120 w 644760"/>
                  <a:gd name="textAreaTop" fmla="*/ 27720 h 671040"/>
                  <a:gd name="textAreaBottom" fmla="*/ 643320 h 671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rot="5400000">
                <a:off x="3626280" y="1625040"/>
                <a:ext cx="527040" cy="794880"/>
              </a:xfrm>
              <a:custGeom>
                <a:avLst/>
                <a:gdLst>
                  <a:gd name="textAreaLeft" fmla="*/ 154800 w 527040"/>
                  <a:gd name="textAreaRight" fmla="*/ 527400 w 527040"/>
                  <a:gd name="textAreaTop" fmla="*/ 33120 h 794880"/>
                  <a:gd name="textAreaBottom" fmla="*/ 761760 h 7948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rot="5400000">
                <a:off x="4360320" y="1685880"/>
                <a:ext cx="585720" cy="731520"/>
              </a:xfrm>
              <a:custGeom>
                <a:avLst/>
                <a:gdLst>
                  <a:gd name="textAreaLeft" fmla="*/ 172080 w 585720"/>
                  <a:gd name="textAreaRight" fmla="*/ 586080 w 585720"/>
                  <a:gd name="textAreaTop" fmla="*/ 30240 h 731520"/>
                  <a:gd name="textAreaBottom" fmla="*/ 701280 h 7315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rot="5400000">
                <a:off x="5033160" y="1744920"/>
                <a:ext cx="644760" cy="672840"/>
              </a:xfrm>
              <a:custGeom>
                <a:avLst/>
                <a:gdLst>
                  <a:gd name="textAreaLeft" fmla="*/ 189360 w 644760"/>
                  <a:gd name="textAreaRight" fmla="*/ 645120 w 644760"/>
                  <a:gd name="textAreaTop" fmla="*/ 27720 h 672840"/>
                  <a:gd name="textAreaBottom" fmla="*/ 645120 h 6728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6303600" y="1582920"/>
                <a:ext cx="426960" cy="468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82044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76336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48408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27788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97664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78304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860120" y="1467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ro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804600" y="2109960"/>
                <a:ext cx="0" cy="176040"/>
              </a:xfrm>
              <a:prstGeom prst="line">
                <a:avLst/>
              </a:prstGeom>
              <a:ln w="76320">
                <a:solidFill>
                  <a:srgbClr val="ff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rot="5400000">
                <a:off x="5976000" y="1474920"/>
                <a:ext cx="409680" cy="977400"/>
              </a:xfrm>
              <a:custGeom>
                <a:avLst/>
                <a:gdLst>
                  <a:gd name="textAreaLeft" fmla="*/ 120240 w 409680"/>
                  <a:gd name="textAreaRight" fmla="*/ 410040 w 409680"/>
                  <a:gd name="textAreaTop" fmla="*/ 40680 h 977400"/>
                  <a:gd name="textAreaBottom" fmla="*/ 936720 h 9774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rot="16200000">
                <a:off x="605520" y="2890800"/>
                <a:ext cx="46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rot="16200000">
                <a:off x="684720" y="2948760"/>
                <a:ext cx="579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1-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rot="16200000">
                <a:off x="827640" y="2948760"/>
                <a:ext cx="579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1-3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rot="16200000">
                <a:off x="1031040" y="2890800"/>
                <a:ext cx="46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rot="16200000">
                <a:off x="1168920" y="2890800"/>
                <a:ext cx="46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3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rot="16200000">
                <a:off x="1302480" y="2890800"/>
                <a:ext cx="46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4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rot="16200000">
                <a:off x="1348560" y="2983680"/>
                <a:ext cx="6501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4-1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" name=""/>
            <p:cNvGrpSpPr/>
            <p:nvPr/>
          </p:nvGrpSpPr>
          <p:grpSpPr>
            <a:xfrm>
              <a:off x="139680" y="5467320"/>
              <a:ext cx="6567480" cy="2346480"/>
              <a:chOff x="139680" y="5467320"/>
              <a:chExt cx="6567480" cy="2346480"/>
            </a:xfrm>
          </p:grpSpPr>
          <p:pic>
            <p:nvPicPr>
              <p:cNvPr id="89" name="" descr=""/>
              <p:cNvPicPr/>
              <p:nvPr/>
            </p:nvPicPr>
            <p:blipFill>
              <a:blip r:embed="rId3"/>
              <a:srcRect l="0" t="62501" r="0" b="34800"/>
              <a:stretch/>
            </p:blipFill>
            <p:spPr>
              <a:xfrm>
                <a:off x="139680" y="5910120"/>
                <a:ext cx="6567480" cy="189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0" name=""/>
              <p:cNvSpPr/>
              <p:nvPr/>
            </p:nvSpPr>
            <p:spPr>
              <a:xfrm>
                <a:off x="700200" y="6370560"/>
                <a:ext cx="243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712800" y="6624360"/>
                <a:ext cx="21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700200" y="6840360"/>
                <a:ext cx="36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614600" y="6840360"/>
                <a:ext cx="203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646440" y="7081560"/>
                <a:ext cx="153684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611600" y="7323120"/>
                <a:ext cx="167652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6097680" y="7538760"/>
                <a:ext cx="19044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079280" y="615312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Il1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700200" y="6370560"/>
                <a:ext cx="243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712800" y="6624360"/>
                <a:ext cx="21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700200" y="6370560"/>
                <a:ext cx="243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700200" y="6840360"/>
                <a:ext cx="36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712800" y="6624360"/>
                <a:ext cx="21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700200" y="6370560"/>
                <a:ext cx="243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1614600" y="6840360"/>
                <a:ext cx="203184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700200" y="6840360"/>
                <a:ext cx="36828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712800" y="6624360"/>
                <a:ext cx="21600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700200" y="6370560"/>
                <a:ext cx="243828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537480" y="6406920"/>
                <a:ext cx="603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1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537480" y="6622920"/>
                <a:ext cx="603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1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408760" y="6622920"/>
                <a:ext cx="47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123440" y="6864120"/>
                <a:ext cx="47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5215680" y="7105680"/>
                <a:ext cx="47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5838120" y="7321320"/>
                <a:ext cx="678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1-4-1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992160" y="6014880"/>
                <a:ext cx="749160" cy="0"/>
              </a:xfrm>
              <a:prstGeom prst="line">
                <a:avLst/>
              </a:prstGeom>
              <a:ln w="1778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992160" y="5938560"/>
                <a:ext cx="0" cy="1524240"/>
              </a:xfrm>
              <a:prstGeom prst="line">
                <a:avLst/>
              </a:prstGeom>
              <a:ln w="1908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1754280" y="5925960"/>
                <a:ext cx="0" cy="1562040"/>
              </a:xfrm>
              <a:prstGeom prst="line">
                <a:avLst/>
              </a:prstGeom>
              <a:ln w="1908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688320" y="753732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7C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1450440" y="753732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1C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155520" y="546732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0" name=""/>
            <p:cNvSpPr/>
            <p:nvPr/>
          </p:nvSpPr>
          <p:spPr>
            <a:xfrm>
              <a:off x="290880" y="11095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4:05:19Z</dcterms:modified>
  <cp:revision>11</cp:revision>
  <dc:subject/>
  <dc:title>Slide 1</dc:title>
</cp:coreProperties>
</file>